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BED60AC-13E3-403D-BC50-D96EB8FFC6B2}" v="2" dt="2026-04-22T14:01:33.93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51" d="100"/>
          <a:sy n="151" d="100"/>
        </p:scale>
        <p:origin x="654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enjamin Benzon" userId="c67122a78fe62ff7" providerId="LiveId" clId="{E5F9D097-4585-4F9B-A4EB-115FBD1314F8}"/>
    <pc:docChg chg="addSld delSld modSld">
      <pc:chgData name="Benjamin Benzon" userId="c67122a78fe62ff7" providerId="LiveId" clId="{E5F9D097-4585-4F9B-A4EB-115FBD1314F8}" dt="2026-04-22T14:01:41.314" v="33" actId="20577"/>
      <pc:docMkLst>
        <pc:docMk/>
      </pc:docMkLst>
      <pc:sldChg chg="new del">
        <pc:chgData name="Benjamin Benzon" userId="c67122a78fe62ff7" providerId="LiveId" clId="{E5F9D097-4585-4F9B-A4EB-115FBD1314F8}" dt="2026-04-22T13:57:11.095" v="2" actId="2696"/>
        <pc:sldMkLst>
          <pc:docMk/>
          <pc:sldMk cId="3177390263" sldId="256"/>
        </pc:sldMkLst>
      </pc:sldChg>
      <pc:sldChg chg="addSp modSp new mod">
        <pc:chgData name="Benjamin Benzon" userId="c67122a78fe62ff7" providerId="LiveId" clId="{E5F9D097-4585-4F9B-A4EB-115FBD1314F8}" dt="2026-04-22T14:01:41.314" v="33" actId="20577"/>
        <pc:sldMkLst>
          <pc:docMk/>
          <pc:sldMk cId="3610912411" sldId="257"/>
        </pc:sldMkLst>
        <pc:spChg chg="add mod">
          <ac:chgData name="Benjamin Benzon" userId="c67122a78fe62ff7" providerId="LiveId" clId="{E5F9D097-4585-4F9B-A4EB-115FBD1314F8}" dt="2026-04-22T14:01:24.068" v="26" actId="20577"/>
          <ac:spMkLst>
            <pc:docMk/>
            <pc:sldMk cId="3610912411" sldId="257"/>
            <ac:spMk id="7" creationId="{1A7076E3-0736-D103-9D0F-A0413F056EEB}"/>
          </ac:spMkLst>
        </pc:spChg>
        <pc:spChg chg="add mod">
          <ac:chgData name="Benjamin Benzon" userId="c67122a78fe62ff7" providerId="LiveId" clId="{E5F9D097-4585-4F9B-A4EB-115FBD1314F8}" dt="2026-04-22T14:01:29.464" v="29" actId="20577"/>
          <ac:spMkLst>
            <pc:docMk/>
            <pc:sldMk cId="3610912411" sldId="257"/>
            <ac:spMk id="8" creationId="{DA66D602-3F6D-1876-28F6-C129A7FB7B45}"/>
          </ac:spMkLst>
        </pc:spChg>
        <pc:spChg chg="add mod">
          <ac:chgData name="Benjamin Benzon" userId="c67122a78fe62ff7" providerId="LiveId" clId="{E5F9D097-4585-4F9B-A4EB-115FBD1314F8}" dt="2026-04-22T14:01:41.314" v="33" actId="20577"/>
          <ac:spMkLst>
            <pc:docMk/>
            <pc:sldMk cId="3610912411" sldId="257"/>
            <ac:spMk id="9" creationId="{1479182E-F25F-40C3-AD0E-9C71F1AC32D0}"/>
          </ac:spMkLst>
        </pc:spChg>
        <pc:picChg chg="add mod">
          <ac:chgData name="Benjamin Benzon" userId="c67122a78fe62ff7" providerId="LiveId" clId="{E5F9D097-4585-4F9B-A4EB-115FBD1314F8}" dt="2026-04-22T13:57:35.237" v="6" actId="14100"/>
          <ac:picMkLst>
            <pc:docMk/>
            <pc:sldMk cId="3610912411" sldId="257"/>
            <ac:picMk id="3" creationId="{EADA7FBF-4EF5-0EFA-91A2-BAB33CE8FF1A}"/>
          </ac:picMkLst>
        </pc:picChg>
        <pc:picChg chg="add mod">
          <ac:chgData name="Benjamin Benzon" userId="c67122a78fe62ff7" providerId="LiveId" clId="{E5F9D097-4585-4F9B-A4EB-115FBD1314F8}" dt="2026-04-22T14:01:14.282" v="21" actId="1076"/>
          <ac:picMkLst>
            <pc:docMk/>
            <pc:sldMk cId="3610912411" sldId="257"/>
            <ac:picMk id="5" creationId="{CD3FACB8-5F37-35E3-5E08-0DB6A57B80B8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9796DB-B362-E1F0-7B7A-C36057245FC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C2CE207-292C-643B-2D1F-2E6BCFAC02A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7E1D21-1A0B-4429-8EF0-71B5A15E93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A1392-4C14-4699-AA39-B132CB9B9A1E}" type="datetimeFigureOut">
              <a:rPr lang="en-US" smtClean="0"/>
              <a:t>4/22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821EDA-45EC-F79D-40DB-BA4C3BA99E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F27083-793C-CC67-584E-5C8AC540DD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E09CC-EBBB-4599-9C21-AE7CF9F1E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6082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701F2B-2DFC-B723-46A6-801816090F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9D418AF-155E-4F3B-9D72-1B959F87B0F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E5CA00-60B1-A975-1498-FA9EFFFA1B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A1392-4C14-4699-AA39-B132CB9B9A1E}" type="datetimeFigureOut">
              <a:rPr lang="en-US" smtClean="0"/>
              <a:t>4/22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C850A2-8D2C-39DD-D8E4-0ADCB1D068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FAFFFF-A5C1-C52A-5A33-71A0620782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E09CC-EBBB-4599-9C21-AE7CF9F1E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04542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B2991C3-025B-2A41-4F90-F21C31F2D27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32D64C4-542D-0A81-3F69-CE596AF634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D4B852-1382-BDFD-0A7A-782E73828D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A1392-4C14-4699-AA39-B132CB9B9A1E}" type="datetimeFigureOut">
              <a:rPr lang="en-US" smtClean="0"/>
              <a:t>4/22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9A34F6-4096-0169-58E5-C4F92DC70A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5D6EFC-A599-6662-3208-9A8C805A53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E09CC-EBBB-4599-9C21-AE7CF9F1E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65653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38D012-B08B-2C89-B236-D9B292844A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CB8F345-6667-DD62-9BFE-5E3A68B72B6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74DAED-5313-2AEA-79F2-775BC66DF0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A1392-4C14-4699-AA39-B132CB9B9A1E}" type="datetimeFigureOut">
              <a:rPr lang="en-US" smtClean="0"/>
              <a:t>4/22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B7A4C9-D64A-128E-2ADB-C7808D0A0A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C40D56-71E7-D20C-74EB-9C5A77F363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E09CC-EBBB-4599-9C21-AE7CF9F1E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02391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CDA792-7E28-BFA0-E378-2A87DEAF1A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FE96DF-5AA5-0368-6998-01F39B12E2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BC6416-0BA1-ADFF-E2BB-4A4BA5E643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A1392-4C14-4699-AA39-B132CB9B9A1E}" type="datetimeFigureOut">
              <a:rPr lang="en-US" smtClean="0"/>
              <a:t>4/22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016BEE-8AAC-E9D4-662D-25E121D915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3FBAA2-544E-9E1E-3D67-73E786126F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E09CC-EBBB-4599-9C21-AE7CF9F1E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74700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C5453E-D661-F4EB-2381-2B98113645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64A47F0-3CBE-86B4-4731-1A79673D48A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B59CDA6-AD41-0361-ADA5-25BB6B31C9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3D6E030-759B-671D-401C-9E9CAF22ED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A1392-4C14-4699-AA39-B132CB9B9A1E}" type="datetimeFigureOut">
              <a:rPr lang="en-US" smtClean="0"/>
              <a:t>4/22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4515133-0D33-FCA0-9895-F0E5DA17DE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FC98DA-B2B7-0B9D-4827-FDDBDDB32C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E09CC-EBBB-4599-9C21-AE7CF9F1E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56313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548E54-0D5E-5011-3BAB-4193C29BEB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78C302B-F0C1-43C1-43BE-3EE403134D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D5318D3-78AB-A6C1-40D8-EC334A174D8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E85A010-6A71-88C6-1133-7484F72C04A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30610F5-F59F-989E-2DC2-9A8869C3BFF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EA47F8F-EB77-8693-26D5-E6F83DD92F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A1392-4C14-4699-AA39-B132CB9B9A1E}" type="datetimeFigureOut">
              <a:rPr lang="en-US" smtClean="0"/>
              <a:t>4/22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3D9E9CC-0724-25FB-7F74-F2E78F671D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CCA93B2-444A-F3BE-349F-3647E4D829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E09CC-EBBB-4599-9C21-AE7CF9F1E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12872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4D91D6-BED7-6425-33C0-D87B501312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B344B58-2271-F5E5-2CA4-669CD8396D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A1392-4C14-4699-AA39-B132CB9B9A1E}" type="datetimeFigureOut">
              <a:rPr lang="en-US" smtClean="0"/>
              <a:t>4/22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79623D1-F3A1-3411-4D22-B6AD8501F2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76DB643-13D5-8AB8-0C2B-90FF30E9F6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E09CC-EBBB-4599-9C21-AE7CF9F1E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61218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72DDF25-1399-64C6-6593-01C4F94EF9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A1392-4C14-4699-AA39-B132CB9B9A1E}" type="datetimeFigureOut">
              <a:rPr lang="en-US" smtClean="0"/>
              <a:t>4/22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45A229B-D199-5F87-1E00-EBBA54794C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AC5C951-FECA-7884-0A5B-FD23CC1AF6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E09CC-EBBB-4599-9C21-AE7CF9F1E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42491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822E52-46C5-7384-A192-5B2D827628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98DDE5-410C-137E-8DA4-0E64AF1BC91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3861835-19FB-764A-A574-61170FF297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1B2D476-92F9-949D-D03E-39FBF7BD1C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A1392-4C14-4699-AA39-B132CB9B9A1E}" type="datetimeFigureOut">
              <a:rPr lang="en-US" smtClean="0"/>
              <a:t>4/22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746985C-0B7D-CF1D-08ED-D7211B9D81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E2C2CC1-A654-6AAC-98AF-A496AE4DC0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E09CC-EBBB-4599-9C21-AE7CF9F1E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245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4A7516-EC59-66BF-3D6B-19FBFE5FCA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DF3443A-D101-C0C8-9803-2E53F69D5FD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5294AB2-88A5-1AEA-989A-B859146A249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F1D63C5-5099-FE70-BAE3-331A063E1B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A1392-4C14-4699-AA39-B132CB9B9A1E}" type="datetimeFigureOut">
              <a:rPr lang="en-US" smtClean="0"/>
              <a:t>4/22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47BA27-D4E1-B7A3-983F-02EE7D4DE7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2F3C702-656F-ACA3-DCDA-8B02B2DF81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BE09CC-EBBB-4599-9C21-AE7CF9F1E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63830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E7D770F-9D93-9B6E-D5FC-A71490023C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47D2D79-AFBF-7A63-5D3C-394BCD0E28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FA75B2-A73E-2F56-3005-1B01ECFB372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D5A1392-4C14-4699-AA39-B132CB9B9A1E}" type="datetimeFigureOut">
              <a:rPr lang="en-US" smtClean="0"/>
              <a:t>4/22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2F1538-42A9-73B4-8730-4C895BAF67F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FCE9CA-119F-01C2-4564-10355C190C7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FBE09CC-EBBB-4599-9C21-AE7CF9F1E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12900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ADA7FBF-4EF5-0EFA-91A2-BAB33CE8FF1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506" y="855145"/>
            <a:ext cx="5863621" cy="387941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D3FACB8-5F37-35E3-5E08-0DB6A57B80B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38127" y="1866900"/>
            <a:ext cx="6293642" cy="238421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1A7076E3-0736-D103-9D0F-A0413F056EEB}"/>
              </a:ext>
            </a:extLst>
          </p:cNvPr>
          <p:cNvSpPr txBox="1"/>
          <p:nvPr/>
        </p:nvSpPr>
        <p:spPr>
          <a:xfrm>
            <a:off x="1689100" y="4991100"/>
            <a:ext cx="9175750" cy="16004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/>
              <a:t>Figure S3. Balance and propensity score diagnostics for the rate-control-only stratum (N = 39).</a:t>
            </a:r>
            <a:r>
              <a:rPr lang="en-US" sz="1400" dirty="0"/>
              <a:t> </a:t>
            </a:r>
            <a:r>
              <a:rPr lang="en-US" sz="1400" b="1" dirty="0"/>
              <a:t>(a)</a:t>
            </a:r>
            <a:r>
              <a:rPr lang="en-US" sz="1400" dirty="0"/>
              <a:t> Love plot showing standardized mean differences (SMDs) before (red) and after (green) stabilized IPTW for all baseline covariates; shaded band indicates |SMD| ≤ 0.1. Propensity score model covariates (age, sex, weight, baseline HR, baseline SBP, digoxin) all achieved |SMD| &lt; 0.1 after weighting. </a:t>
            </a:r>
            <a:r>
              <a:rPr lang="en-US" sz="1400" b="1" dirty="0"/>
              <a:t>(b)</a:t>
            </a:r>
            <a:r>
              <a:rPr lang="en-US" sz="1400" dirty="0"/>
              <a:t> Propensity score distribution by diazepam exposure; groups overlap across the range 0.05–0.91, indicating adequate positivity. Stabilized weight distribution by diazepam exposure (mean 0.99, range 0.45–3.20); weights were centered near 1 and summed to approximately the sample size. SMD, standardized mean difference; IPTW, inverse probability of treatment weighting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A66D602-3F6D-1876-28F6-C129A7FB7B45}"/>
              </a:ext>
            </a:extLst>
          </p:cNvPr>
          <p:cNvSpPr txBox="1"/>
          <p:nvPr/>
        </p:nvSpPr>
        <p:spPr>
          <a:xfrm>
            <a:off x="323850" y="558800"/>
            <a:ext cx="3754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479182E-F25F-40C3-AD0E-9C71F1AC32D0}"/>
              </a:ext>
            </a:extLst>
          </p:cNvPr>
          <p:cNvSpPr txBox="1"/>
          <p:nvPr/>
        </p:nvSpPr>
        <p:spPr>
          <a:xfrm>
            <a:off x="5750415" y="558800"/>
            <a:ext cx="3818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  <a:r>
              <a:rPr lang="en-US"/>
              <a:t>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109124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48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enjamin Benzon</dc:creator>
  <cp:lastModifiedBy>Benjamin Benzon</cp:lastModifiedBy>
  <cp:revision>1</cp:revision>
  <dcterms:created xsi:type="dcterms:W3CDTF">2026-04-22T13:57:02Z</dcterms:created>
  <dcterms:modified xsi:type="dcterms:W3CDTF">2026-04-22T14:01:47Z</dcterms:modified>
</cp:coreProperties>
</file>